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83" r:id="rId2"/>
  </p:sldIdLst>
  <p:sldSz cx="9601200" cy="12801600" type="A3"/>
  <p:notesSz cx="6858000" cy="9144000"/>
  <p:defaultTextStyle>
    <a:defPPr>
      <a:defRPr lang="ja-JP"/>
    </a:defPPr>
    <a:lvl1pPr marL="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ru Hanamura" initials="TH" lastIdx="4" clrIdx="0">
    <p:extLst>
      <p:ext uri="{19B8F6BF-5375-455C-9EA6-DF929625EA0E}">
        <p15:presenceInfo xmlns:p15="http://schemas.microsoft.com/office/powerpoint/2012/main" userId="Toru Hanamura" providerId="None"/>
      </p:ext>
    </p:extLst>
  </p:cmAuthor>
  <p:cmAuthor id="2" name="Richer, Jennifer" initials="RJ" lastIdx="6" clrIdx="1">
    <p:extLst>
      <p:ext uri="{19B8F6BF-5375-455C-9EA6-DF929625EA0E}">
        <p15:presenceInfo xmlns:p15="http://schemas.microsoft.com/office/powerpoint/2012/main" userId="Richer, Jennifer" providerId="None"/>
      </p:ext>
    </p:extLst>
  </p:cmAuthor>
  <p:cmAuthor id="3" name="花村 徹" initials="花村" lastIdx="2" clrIdx="2">
    <p:extLst>
      <p:ext uri="{19B8F6BF-5375-455C-9EA6-DF929625EA0E}">
        <p15:presenceInfo xmlns:p15="http://schemas.microsoft.com/office/powerpoint/2012/main" userId="713ce747a82cdf4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116"/>
    <p:restoredTop sz="92993" autoAdjust="0"/>
  </p:normalViewPr>
  <p:slideViewPr>
    <p:cSldViewPr snapToGrid="0" snapToObjects="1">
      <p:cViewPr varScale="1">
        <p:scale>
          <a:sx n="61" d="100"/>
          <a:sy n="61" d="100"/>
        </p:scale>
        <p:origin x="4016" y="224"/>
      </p:cViewPr>
      <p:guideLst/>
    </p:cSldViewPr>
  </p:slideViewPr>
  <p:notesTextViewPr>
    <p:cViewPr>
      <p:scale>
        <a:sx n="95" d="100"/>
        <a:sy n="9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82A602-B26C-764C-9708-93A17553678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45F9A1-8BE5-B546-9533-9E59946FDE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70756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4906203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DA99A-FF6A-744E-AD7B-15F802665C1C}" type="datetimeFigureOut">
              <a:rPr kumimoji="1" lang="ja-JP" altLang="en-US" smtClean="0"/>
              <a:t>2021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233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png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emf"/><Relationship Id="rId5" Type="http://schemas.openxmlformats.org/officeDocument/2006/relationships/image" Target="../media/image3.png"/><Relationship Id="rId10" Type="http://schemas.openxmlformats.org/officeDocument/2006/relationships/image" Target="../media/image8.emf"/><Relationship Id="rId4" Type="http://schemas.openxmlformats.org/officeDocument/2006/relationships/image" Target="../media/image2.png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テキスト ボックス 178"/>
          <p:cNvSpPr txBox="1"/>
          <p:nvPr/>
        </p:nvSpPr>
        <p:spPr>
          <a:xfrm>
            <a:off x="368475" y="520425"/>
            <a:ext cx="3084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charset="0"/>
                <a:ea typeface="Arial" charset="0"/>
                <a:cs typeface="Arial" charset="0"/>
              </a:rPr>
              <a:t>a</a:t>
            </a:r>
            <a:endParaRPr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80" name="テキスト ボックス 179"/>
          <p:cNvSpPr txBox="1"/>
          <p:nvPr/>
        </p:nvSpPr>
        <p:spPr>
          <a:xfrm flipH="1">
            <a:off x="3780567" y="520425"/>
            <a:ext cx="1998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charset="0"/>
                <a:ea typeface="Arial" charset="0"/>
                <a:cs typeface="Arial" charset="0"/>
              </a:rPr>
              <a:t>b</a:t>
            </a:r>
            <a:endParaRPr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6" name="表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27922049"/>
              </p:ext>
            </p:extLst>
          </p:nvPr>
        </p:nvGraphicFramePr>
        <p:xfrm>
          <a:off x="6896738" y="836005"/>
          <a:ext cx="2413843" cy="204598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8752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5261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8594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99341"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en-US" altLang="ja-JP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Subtype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ell lin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IC 50 (</a:t>
                      </a:r>
                      <a:r>
                        <a:rPr lang="el-GR" sz="1000" u="none" strike="noStrike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μM</a:t>
                      </a:r>
                      <a:r>
                        <a:rPr lang="en-US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)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934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ER-</a:t>
                      </a:r>
                      <a:r>
                        <a:rPr lang="en-US" sz="10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/ HER2-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HCC2185</a:t>
                      </a:r>
                      <a:endParaRPr lang="is-I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54.81</a:t>
                      </a:r>
                      <a:endParaRPr lang="hr-H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9341">
                <a:tc>
                  <a:txBody>
                    <a:bodyPr/>
                    <a:lstStyle/>
                    <a:p>
                      <a:pPr algn="l" fontAlgn="b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T-549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0.21</a:t>
                      </a:r>
                      <a:endParaRPr lang="nb-NO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9341">
                <a:tc>
                  <a:txBody>
                    <a:bodyPr/>
                    <a:lstStyle/>
                    <a:p>
                      <a:pPr algn="l" fontAlgn="b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DA-MB-468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6.47</a:t>
                      </a:r>
                      <a:endParaRPr lang="hr-H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ER-</a:t>
                      </a:r>
                      <a:r>
                        <a:rPr lang="en-US" sz="10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/ HER2±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DA-MB-453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6.64</a:t>
                      </a:r>
                      <a:endParaRPr lang="hr-H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934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ER- / HER2+</a:t>
                      </a: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mr-IN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K-BR-3</a:t>
                      </a: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b-NO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50.47</a:t>
                      </a: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934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ER+ / HER2+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T-474</a:t>
                      </a:r>
                      <a:endParaRPr lang="mr-I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51.99</a:t>
                      </a:r>
                      <a:endParaRPr lang="nb-NO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9341">
                <a:tc>
                  <a:txBody>
                    <a:bodyPr/>
                    <a:lstStyle/>
                    <a:p>
                      <a:pPr algn="l" fontAlgn="b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ZR-75-1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66.29</a:t>
                      </a:r>
                      <a:endParaRPr lang="hr-H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1157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ER+</a:t>
                      </a:r>
                      <a:r>
                        <a:rPr lang="en-US" sz="1000" u="none" strike="noStrike" baseline="0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/ HER2-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CF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8.56</a:t>
                      </a:r>
                      <a:endParaRPr lang="hr-H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9341">
                <a:tc>
                  <a:txBody>
                    <a:bodyPr/>
                    <a:lstStyle/>
                    <a:p>
                      <a:pPr algn="l" fontAlgn="b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-47D</a:t>
                      </a:r>
                      <a:endParaRPr lang="mr-I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0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8.31</a:t>
                      </a:r>
                      <a:endParaRPr lang="hr-H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36005" marR="36005" marT="18002" marB="18002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sp>
        <p:nvSpPr>
          <p:cNvPr id="17" name="テキスト ボックス 16"/>
          <p:cNvSpPr txBox="1"/>
          <p:nvPr/>
        </p:nvSpPr>
        <p:spPr>
          <a:xfrm>
            <a:off x="13971172" y="6932955"/>
            <a:ext cx="184731" cy="3105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ja-JP" altLang="en-US" sz="1418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307882" y="165898"/>
            <a:ext cx="28716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Arial" charset="0"/>
                <a:ea typeface="Arial" charset="0"/>
                <a:cs typeface="Arial" charset="0"/>
              </a:rPr>
              <a:t>Fig. S2</a:t>
            </a:r>
            <a:endParaRPr kumimoji="1"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50281" y="3391830"/>
            <a:ext cx="3084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charset="0"/>
                <a:ea typeface="Arial" charset="0"/>
                <a:cs typeface="Arial" charset="0"/>
              </a:rPr>
              <a:t>c</a:t>
            </a:r>
            <a:endParaRPr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2972" y="711153"/>
            <a:ext cx="2738524" cy="2449170"/>
          </a:xfrm>
          <a:prstGeom prst="rect">
            <a:avLst/>
          </a:prstGeom>
        </p:spPr>
      </p:pic>
      <p:graphicFrame>
        <p:nvGraphicFramePr>
          <p:cNvPr id="13" name="表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1196623"/>
              </p:ext>
            </p:extLst>
          </p:nvPr>
        </p:nvGraphicFramePr>
        <p:xfrm>
          <a:off x="6896737" y="3614297"/>
          <a:ext cx="2413843" cy="2077826"/>
        </p:xfrm>
        <a:graphic>
          <a:graphicData uri="http://schemas.openxmlformats.org/drawingml/2006/table">
            <a:tbl>
              <a:tblPr/>
              <a:tblGrid>
                <a:gridCol w="80882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8854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1647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7150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Cell l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Proliferative response to DHT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IC 50 (μM)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9544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DA-MB 45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Promotiv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6.6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9544">
                <a:tc>
                  <a:txBody>
                    <a:bodyPr/>
                    <a:lstStyle/>
                    <a:p>
                      <a:pPr algn="l" fontAlgn="b"/>
                      <a:r>
                        <a:rPr lang="is-I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HCC 218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uppressiv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54.8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9544">
                <a:tc>
                  <a:txBody>
                    <a:bodyPr/>
                    <a:lstStyle/>
                    <a:p>
                      <a:pPr algn="l" fontAlgn="b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BT 54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No respon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0.2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9544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DA-MB 46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No respon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6.4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9544">
                <a:tc>
                  <a:txBody>
                    <a:bodyPr/>
                    <a:lstStyle/>
                    <a:p>
                      <a:pPr algn="l" fontAlgn="b"/>
                      <a:r>
                        <a:rPr lang="ru-RU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ZR-75-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No respon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66.2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9544">
                <a:tc>
                  <a:txBody>
                    <a:bodyPr/>
                    <a:lstStyle/>
                    <a:p>
                      <a:pPr algn="l" fontAlgn="b"/>
                      <a:r>
                        <a:rPr lang="nl-NL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K-BR-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No respon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50.4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9544">
                <a:tc>
                  <a:txBody>
                    <a:bodyPr/>
                    <a:lstStyle/>
                    <a:p>
                      <a:pPr algn="l" fontAlgn="b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BT 47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uppressiv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51.9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9544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CF-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Suppressiv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8.5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9967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T47D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Promotiv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r-H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8.3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pic>
        <p:nvPicPr>
          <p:cNvPr id="12" name="図 11">
            <a:extLst>
              <a:ext uri="{FF2B5EF4-FFF2-40B4-BE49-F238E27FC236}">
                <a16:creationId xmlns:a16="http://schemas.microsoft.com/office/drawing/2014/main" id="{AB5E7882-9060-6949-8BAE-B4C5576C47B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60079" y="3614297"/>
            <a:ext cx="2838439" cy="2508882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B16B71FB-3C42-904A-BC84-1175D0D4925F}"/>
              </a:ext>
            </a:extLst>
          </p:cNvPr>
          <p:cNvSpPr txBox="1"/>
          <p:nvPr/>
        </p:nvSpPr>
        <p:spPr>
          <a:xfrm flipH="1">
            <a:off x="3765721" y="3385836"/>
            <a:ext cx="1998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charset="0"/>
                <a:ea typeface="Arial" charset="0"/>
                <a:cs typeface="Arial" charset="0"/>
              </a:rPr>
              <a:t>d</a:t>
            </a:r>
            <a:endParaRPr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B31A348F-83B1-5244-9717-E6C4BF07D91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3571" y="711153"/>
            <a:ext cx="3305726" cy="2462429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B2FAD156-5CBF-354D-9281-9CE26A34397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8833" y="3614297"/>
            <a:ext cx="3173017" cy="2379763"/>
          </a:xfrm>
          <a:prstGeom prst="rect">
            <a:avLst/>
          </a:prstGeom>
        </p:spPr>
      </p:pic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505594C8-62C1-8D46-8E15-A3116DFA0658}"/>
              </a:ext>
            </a:extLst>
          </p:cNvPr>
          <p:cNvSpPr txBox="1"/>
          <p:nvPr/>
        </p:nvSpPr>
        <p:spPr>
          <a:xfrm flipH="1">
            <a:off x="259004" y="6494419"/>
            <a:ext cx="1998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charset="0"/>
                <a:ea typeface="Arial" charset="0"/>
                <a:cs typeface="Arial" charset="0"/>
              </a:rPr>
              <a:t>e</a:t>
            </a:r>
            <a:endParaRPr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8C8A9827-50CB-F24B-8D5B-1E2E4E5685FA}"/>
              </a:ext>
            </a:extLst>
          </p:cNvPr>
          <p:cNvSpPr/>
          <p:nvPr/>
        </p:nvSpPr>
        <p:spPr>
          <a:xfrm>
            <a:off x="565380" y="5674193"/>
            <a:ext cx="501792" cy="1075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F816A00-8C8A-714C-95F5-07E010B590B2}"/>
              </a:ext>
            </a:extLst>
          </p:cNvPr>
          <p:cNvSpPr txBox="1"/>
          <p:nvPr/>
        </p:nvSpPr>
        <p:spPr>
          <a:xfrm>
            <a:off x="704217" y="5611293"/>
            <a:ext cx="24204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A0E63EA2-4F94-A744-9ACB-B2D359505E9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07128" y="9259321"/>
            <a:ext cx="2870200" cy="279400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AAF149B4-C3DA-7A4B-8E18-20EF6CBA439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141911" y="6342697"/>
            <a:ext cx="2667000" cy="284480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6CA35666-041F-664F-8173-7C4D9A655E4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67567" y="6329997"/>
            <a:ext cx="2705100" cy="285750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AE8E66F1-77F1-3946-B970-A76697FE3C6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103811" y="9259321"/>
            <a:ext cx="2705100" cy="2844800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4E5A22F8-0AE9-D045-BB0A-3FA965899B2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735393" y="9259321"/>
            <a:ext cx="2882900" cy="2844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359556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919</TotalTime>
  <Words>103</Words>
  <Application>Microsoft Macintosh PowerPoint</Application>
  <PresentationFormat>A3 297x420 mm</PresentationFormat>
  <Paragraphs>6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Yu Gothic</vt:lpstr>
      <vt:lpstr>Arial</vt:lpstr>
      <vt:lpstr>Calibri</vt:lpstr>
      <vt:lpstr>Calibri Light</vt:lpstr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花村 徹</dc:creator>
  <cp:keywords/>
  <dc:description/>
  <cp:lastModifiedBy>花村 徹</cp:lastModifiedBy>
  <cp:revision>647</cp:revision>
  <cp:lastPrinted>2019-11-15T20:26:41Z</cp:lastPrinted>
  <dcterms:created xsi:type="dcterms:W3CDTF">2019-06-11T17:31:31Z</dcterms:created>
  <dcterms:modified xsi:type="dcterms:W3CDTF">2021-10-25T00:51:42Z</dcterms:modified>
  <cp:category/>
</cp:coreProperties>
</file>